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4401800" cy="1440021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4536" userDrawn="1">
          <p15:clr>
            <a:srgbClr val="A4A3A4"/>
          </p15:clr>
        </p15:guide>
        <p15:guide id="2" pos="45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044" y="726"/>
      </p:cViewPr>
      <p:guideLst>
        <p:guide orient="horz" pos="4536"/>
        <p:guide pos="45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080135" y="4473403"/>
            <a:ext cx="12241530" cy="308671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2160270" y="8160120"/>
            <a:ext cx="10081260" cy="368005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813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626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4402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1253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4067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880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9693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2507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627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7496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16444561" y="576680"/>
            <a:ext cx="5103137" cy="1228684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1135143" y="576680"/>
            <a:ext cx="15069384" cy="1228684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6568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8747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137643" y="9253473"/>
            <a:ext cx="12241530" cy="2860043"/>
          </a:xfrm>
        </p:spPr>
        <p:txBody>
          <a:bodyPr anchor="t"/>
          <a:lstStyle>
            <a:lvl1pPr algn="l">
              <a:defRPr sz="2462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137643" y="6103426"/>
            <a:ext cx="12241530" cy="3150046"/>
          </a:xfrm>
        </p:spPr>
        <p:txBody>
          <a:bodyPr anchor="b"/>
          <a:lstStyle>
            <a:lvl1pPr marL="0" indent="0">
              <a:buNone/>
              <a:defRPr sz="1230">
                <a:solidFill>
                  <a:schemeClr val="tx1">
                    <a:tint val="75000"/>
                  </a:schemeClr>
                </a:solidFill>
              </a:defRPr>
            </a:lvl1pPr>
            <a:lvl2pPr marL="281342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2pPr>
            <a:lvl3pPr marL="562685" indent="0">
              <a:buNone/>
              <a:defRPr sz="985">
                <a:solidFill>
                  <a:schemeClr val="tx1">
                    <a:tint val="75000"/>
                  </a:schemeClr>
                </a:solidFill>
              </a:defRPr>
            </a:lvl3pPr>
            <a:lvl4pPr marL="844028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4pPr>
            <a:lvl5pPr marL="1125370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5pPr>
            <a:lvl6pPr marL="1406713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6pPr>
            <a:lvl7pPr marL="1688055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7pPr>
            <a:lvl8pPr marL="1969398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8pPr>
            <a:lvl9pPr marL="2250741" indent="0">
              <a:buNone/>
              <a:defRPr sz="86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6169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1135146" y="3360054"/>
            <a:ext cx="10086261" cy="9503475"/>
          </a:xfrm>
        </p:spPr>
        <p:txBody>
          <a:bodyPr/>
          <a:lstStyle>
            <a:lvl1pPr>
              <a:defRPr sz="1723"/>
            </a:lvl1pPr>
            <a:lvl2pPr>
              <a:defRPr sz="1477"/>
            </a:lvl2pPr>
            <a:lvl3pPr>
              <a:defRPr sz="1230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11461435" y="3360054"/>
            <a:ext cx="10086261" cy="9503475"/>
          </a:xfrm>
        </p:spPr>
        <p:txBody>
          <a:bodyPr/>
          <a:lstStyle>
            <a:lvl1pPr>
              <a:defRPr sz="1723"/>
            </a:lvl1pPr>
            <a:lvl2pPr>
              <a:defRPr sz="1477"/>
            </a:lvl2pPr>
            <a:lvl3pPr>
              <a:defRPr sz="1230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95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0090" y="576676"/>
            <a:ext cx="12961620" cy="2400036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0090" y="3223382"/>
            <a:ext cx="6363296" cy="1343352"/>
          </a:xfrm>
        </p:spPr>
        <p:txBody>
          <a:bodyPr anchor="b"/>
          <a:lstStyle>
            <a:lvl1pPr marL="0" indent="0">
              <a:buNone/>
              <a:defRPr sz="1477" b="1"/>
            </a:lvl1pPr>
            <a:lvl2pPr marL="281342" indent="0">
              <a:buNone/>
              <a:defRPr sz="1230" b="1"/>
            </a:lvl2pPr>
            <a:lvl3pPr marL="562685" indent="0">
              <a:buNone/>
              <a:defRPr sz="1108" b="1"/>
            </a:lvl3pPr>
            <a:lvl4pPr marL="844028" indent="0">
              <a:buNone/>
              <a:defRPr sz="985" b="1"/>
            </a:lvl4pPr>
            <a:lvl5pPr marL="1125370" indent="0">
              <a:buNone/>
              <a:defRPr sz="985" b="1"/>
            </a:lvl5pPr>
            <a:lvl6pPr marL="1406713" indent="0">
              <a:buNone/>
              <a:defRPr sz="985" b="1"/>
            </a:lvl6pPr>
            <a:lvl7pPr marL="1688055" indent="0">
              <a:buNone/>
              <a:defRPr sz="985" b="1"/>
            </a:lvl7pPr>
            <a:lvl8pPr marL="1969398" indent="0">
              <a:buNone/>
              <a:defRPr sz="985" b="1"/>
            </a:lvl8pPr>
            <a:lvl9pPr marL="2250741" indent="0">
              <a:buNone/>
              <a:defRPr sz="985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720090" y="4566735"/>
            <a:ext cx="6363296" cy="8296790"/>
          </a:xfrm>
        </p:spPr>
        <p:txBody>
          <a:bodyPr/>
          <a:lstStyle>
            <a:lvl1pPr>
              <a:defRPr sz="1477"/>
            </a:lvl1pPr>
            <a:lvl2pPr>
              <a:defRPr sz="1230"/>
            </a:lvl2pPr>
            <a:lvl3pPr>
              <a:defRPr sz="1108"/>
            </a:lvl3pPr>
            <a:lvl4pPr>
              <a:defRPr sz="985"/>
            </a:lvl4pPr>
            <a:lvl5pPr>
              <a:defRPr sz="985"/>
            </a:lvl5pPr>
            <a:lvl6pPr>
              <a:defRPr sz="985"/>
            </a:lvl6pPr>
            <a:lvl7pPr>
              <a:defRPr sz="985"/>
            </a:lvl7pPr>
            <a:lvl8pPr>
              <a:defRPr sz="985"/>
            </a:lvl8pPr>
            <a:lvl9pPr>
              <a:defRPr sz="985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7315915" y="3223382"/>
            <a:ext cx="6365796" cy="1343352"/>
          </a:xfrm>
        </p:spPr>
        <p:txBody>
          <a:bodyPr anchor="b"/>
          <a:lstStyle>
            <a:lvl1pPr marL="0" indent="0">
              <a:buNone/>
              <a:defRPr sz="1477" b="1"/>
            </a:lvl1pPr>
            <a:lvl2pPr marL="281342" indent="0">
              <a:buNone/>
              <a:defRPr sz="1230" b="1"/>
            </a:lvl2pPr>
            <a:lvl3pPr marL="562685" indent="0">
              <a:buNone/>
              <a:defRPr sz="1108" b="1"/>
            </a:lvl3pPr>
            <a:lvl4pPr marL="844028" indent="0">
              <a:buNone/>
              <a:defRPr sz="985" b="1"/>
            </a:lvl4pPr>
            <a:lvl5pPr marL="1125370" indent="0">
              <a:buNone/>
              <a:defRPr sz="985" b="1"/>
            </a:lvl5pPr>
            <a:lvl6pPr marL="1406713" indent="0">
              <a:buNone/>
              <a:defRPr sz="985" b="1"/>
            </a:lvl6pPr>
            <a:lvl7pPr marL="1688055" indent="0">
              <a:buNone/>
              <a:defRPr sz="985" b="1"/>
            </a:lvl7pPr>
            <a:lvl8pPr marL="1969398" indent="0">
              <a:buNone/>
              <a:defRPr sz="985" b="1"/>
            </a:lvl8pPr>
            <a:lvl9pPr marL="2250741" indent="0">
              <a:buNone/>
              <a:defRPr sz="985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7315915" y="4566735"/>
            <a:ext cx="6365796" cy="8296790"/>
          </a:xfrm>
        </p:spPr>
        <p:txBody>
          <a:bodyPr/>
          <a:lstStyle>
            <a:lvl1pPr>
              <a:defRPr sz="1477"/>
            </a:lvl1pPr>
            <a:lvl2pPr>
              <a:defRPr sz="1230"/>
            </a:lvl2pPr>
            <a:lvl3pPr>
              <a:defRPr sz="1108"/>
            </a:lvl3pPr>
            <a:lvl4pPr>
              <a:defRPr sz="985"/>
            </a:lvl4pPr>
            <a:lvl5pPr>
              <a:defRPr sz="985"/>
            </a:lvl5pPr>
            <a:lvl6pPr>
              <a:defRPr sz="985"/>
            </a:lvl6pPr>
            <a:lvl7pPr>
              <a:defRPr sz="985"/>
            </a:lvl7pPr>
            <a:lvl8pPr>
              <a:defRPr sz="985"/>
            </a:lvl8pPr>
            <a:lvl9pPr>
              <a:defRPr sz="985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2955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3210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3606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0095" y="573342"/>
            <a:ext cx="4738093" cy="2440037"/>
          </a:xfrm>
        </p:spPr>
        <p:txBody>
          <a:bodyPr anchor="b"/>
          <a:lstStyle>
            <a:lvl1pPr algn="l">
              <a:defRPr sz="123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630704" y="573345"/>
            <a:ext cx="8051006" cy="12290183"/>
          </a:xfrm>
        </p:spPr>
        <p:txBody>
          <a:bodyPr/>
          <a:lstStyle>
            <a:lvl1pPr>
              <a:defRPr sz="1969"/>
            </a:lvl1pPr>
            <a:lvl2pPr>
              <a:defRPr sz="1723"/>
            </a:lvl2pPr>
            <a:lvl3pPr>
              <a:defRPr sz="1477"/>
            </a:lvl3pPr>
            <a:lvl4pPr>
              <a:defRPr sz="1230"/>
            </a:lvl4pPr>
            <a:lvl5pPr>
              <a:defRPr sz="1230"/>
            </a:lvl5pPr>
            <a:lvl6pPr>
              <a:defRPr sz="1230"/>
            </a:lvl6pPr>
            <a:lvl7pPr>
              <a:defRPr sz="1230"/>
            </a:lvl7pPr>
            <a:lvl8pPr>
              <a:defRPr sz="1230"/>
            </a:lvl8pPr>
            <a:lvl9pPr>
              <a:defRPr sz="123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720095" y="3013382"/>
            <a:ext cx="4738093" cy="9850146"/>
          </a:xfrm>
        </p:spPr>
        <p:txBody>
          <a:bodyPr/>
          <a:lstStyle>
            <a:lvl1pPr marL="0" indent="0">
              <a:buNone/>
              <a:defRPr sz="862"/>
            </a:lvl1pPr>
            <a:lvl2pPr marL="281342" indent="0">
              <a:buNone/>
              <a:defRPr sz="738"/>
            </a:lvl2pPr>
            <a:lvl3pPr marL="562685" indent="0">
              <a:buNone/>
              <a:defRPr sz="615"/>
            </a:lvl3pPr>
            <a:lvl4pPr marL="844028" indent="0">
              <a:buNone/>
              <a:defRPr sz="554"/>
            </a:lvl4pPr>
            <a:lvl5pPr marL="1125370" indent="0">
              <a:buNone/>
              <a:defRPr sz="554"/>
            </a:lvl5pPr>
            <a:lvl6pPr marL="1406713" indent="0">
              <a:buNone/>
              <a:defRPr sz="554"/>
            </a:lvl6pPr>
            <a:lvl7pPr marL="1688055" indent="0">
              <a:buNone/>
              <a:defRPr sz="554"/>
            </a:lvl7pPr>
            <a:lvl8pPr marL="1969398" indent="0">
              <a:buNone/>
              <a:defRPr sz="554"/>
            </a:lvl8pPr>
            <a:lvl9pPr marL="2250741" indent="0">
              <a:buNone/>
              <a:defRPr sz="554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6115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822854" y="10080150"/>
            <a:ext cx="8641080" cy="1190019"/>
          </a:xfrm>
        </p:spPr>
        <p:txBody>
          <a:bodyPr anchor="b"/>
          <a:lstStyle>
            <a:lvl1pPr algn="l">
              <a:defRPr sz="123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822854" y="1286685"/>
            <a:ext cx="8641080" cy="8640128"/>
          </a:xfrm>
        </p:spPr>
        <p:txBody>
          <a:bodyPr/>
          <a:lstStyle>
            <a:lvl1pPr marL="0" indent="0">
              <a:buNone/>
              <a:defRPr sz="1969"/>
            </a:lvl1pPr>
            <a:lvl2pPr marL="281342" indent="0">
              <a:buNone/>
              <a:defRPr sz="1723"/>
            </a:lvl2pPr>
            <a:lvl3pPr marL="562685" indent="0">
              <a:buNone/>
              <a:defRPr sz="1477"/>
            </a:lvl3pPr>
            <a:lvl4pPr marL="844028" indent="0">
              <a:buNone/>
              <a:defRPr sz="1230"/>
            </a:lvl4pPr>
            <a:lvl5pPr marL="1125370" indent="0">
              <a:buNone/>
              <a:defRPr sz="1230"/>
            </a:lvl5pPr>
            <a:lvl6pPr marL="1406713" indent="0">
              <a:buNone/>
              <a:defRPr sz="1230"/>
            </a:lvl6pPr>
            <a:lvl7pPr marL="1688055" indent="0">
              <a:buNone/>
              <a:defRPr sz="1230"/>
            </a:lvl7pPr>
            <a:lvl8pPr marL="1969398" indent="0">
              <a:buNone/>
              <a:defRPr sz="1230"/>
            </a:lvl8pPr>
            <a:lvl9pPr marL="2250741" indent="0">
              <a:buNone/>
              <a:defRPr sz="123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822854" y="11270168"/>
            <a:ext cx="8641080" cy="1690024"/>
          </a:xfrm>
        </p:spPr>
        <p:txBody>
          <a:bodyPr/>
          <a:lstStyle>
            <a:lvl1pPr marL="0" indent="0">
              <a:buNone/>
              <a:defRPr sz="862"/>
            </a:lvl1pPr>
            <a:lvl2pPr marL="281342" indent="0">
              <a:buNone/>
              <a:defRPr sz="738"/>
            </a:lvl2pPr>
            <a:lvl3pPr marL="562685" indent="0">
              <a:buNone/>
              <a:defRPr sz="615"/>
            </a:lvl3pPr>
            <a:lvl4pPr marL="844028" indent="0">
              <a:buNone/>
              <a:defRPr sz="554"/>
            </a:lvl4pPr>
            <a:lvl5pPr marL="1125370" indent="0">
              <a:buNone/>
              <a:defRPr sz="554"/>
            </a:lvl5pPr>
            <a:lvl6pPr marL="1406713" indent="0">
              <a:buNone/>
              <a:defRPr sz="554"/>
            </a:lvl6pPr>
            <a:lvl7pPr marL="1688055" indent="0">
              <a:buNone/>
              <a:defRPr sz="554"/>
            </a:lvl7pPr>
            <a:lvl8pPr marL="1969398" indent="0">
              <a:buNone/>
              <a:defRPr sz="554"/>
            </a:lvl8pPr>
            <a:lvl9pPr marL="2250741" indent="0">
              <a:buNone/>
              <a:defRPr sz="554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617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720090" y="576676"/>
            <a:ext cx="12961620" cy="24000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0090" y="3360054"/>
            <a:ext cx="12961620" cy="95034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720090" y="13346868"/>
            <a:ext cx="33604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D147D-CE4B-4E9F-873D-17B9BD5F895B}" type="datetimeFigureOut">
              <a:rPr lang="fr-FR" smtClean="0"/>
              <a:t>11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920615" y="13346868"/>
            <a:ext cx="456057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10321290" y="13346868"/>
            <a:ext cx="336042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AD1430-6EEA-42C6-A009-41988623771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5435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62685" rtl="0" eaLnBrk="1" latinLnBrk="0" hangingPunct="1">
        <a:spcBef>
          <a:spcPct val="0"/>
        </a:spcBef>
        <a:buNone/>
        <a:defRPr sz="27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1007" indent="-211007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969" kern="1200">
          <a:solidFill>
            <a:schemeClr val="tx1"/>
          </a:solidFill>
          <a:latin typeface="+mn-lt"/>
          <a:ea typeface="+mn-ea"/>
          <a:cs typeface="+mn-cs"/>
        </a:defRPr>
      </a:lvl1pPr>
      <a:lvl2pPr marL="457182" indent="-175839" algn="l" defTabSz="562685" rtl="0" eaLnBrk="1" latinLnBrk="0" hangingPunct="1">
        <a:spcBef>
          <a:spcPct val="20000"/>
        </a:spcBef>
        <a:buFont typeface="Arial" panose="020B0604020202020204" pitchFamily="34" charset="0"/>
        <a:buChar char="–"/>
        <a:defRPr sz="1723" kern="1200">
          <a:solidFill>
            <a:schemeClr val="tx1"/>
          </a:solidFill>
          <a:latin typeface="+mn-lt"/>
          <a:ea typeface="+mn-ea"/>
          <a:cs typeface="+mn-cs"/>
        </a:defRPr>
      </a:lvl2pPr>
      <a:lvl3pPr marL="703357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477" kern="1200">
          <a:solidFill>
            <a:schemeClr val="tx1"/>
          </a:solidFill>
          <a:latin typeface="+mn-lt"/>
          <a:ea typeface="+mn-ea"/>
          <a:cs typeface="+mn-cs"/>
        </a:defRPr>
      </a:lvl3pPr>
      <a:lvl4pPr marL="984699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–"/>
        <a:defRPr sz="1230" kern="1200">
          <a:solidFill>
            <a:schemeClr val="tx1"/>
          </a:solidFill>
          <a:latin typeface="+mn-lt"/>
          <a:ea typeface="+mn-ea"/>
          <a:cs typeface="+mn-cs"/>
        </a:defRPr>
      </a:lvl4pPr>
      <a:lvl5pPr marL="1266042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»"/>
        <a:defRPr sz="1230" kern="1200">
          <a:solidFill>
            <a:schemeClr val="tx1"/>
          </a:solidFill>
          <a:latin typeface="+mn-lt"/>
          <a:ea typeface="+mn-ea"/>
          <a:cs typeface="+mn-cs"/>
        </a:defRPr>
      </a:lvl5pPr>
      <a:lvl6pPr marL="1547384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230" kern="1200">
          <a:solidFill>
            <a:schemeClr val="tx1"/>
          </a:solidFill>
          <a:latin typeface="+mn-lt"/>
          <a:ea typeface="+mn-ea"/>
          <a:cs typeface="+mn-cs"/>
        </a:defRPr>
      </a:lvl6pPr>
      <a:lvl7pPr marL="1828727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230" kern="1200">
          <a:solidFill>
            <a:schemeClr val="tx1"/>
          </a:solidFill>
          <a:latin typeface="+mn-lt"/>
          <a:ea typeface="+mn-ea"/>
          <a:cs typeface="+mn-cs"/>
        </a:defRPr>
      </a:lvl7pPr>
      <a:lvl8pPr marL="2110070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230" kern="1200">
          <a:solidFill>
            <a:schemeClr val="tx1"/>
          </a:solidFill>
          <a:latin typeface="+mn-lt"/>
          <a:ea typeface="+mn-ea"/>
          <a:cs typeface="+mn-cs"/>
        </a:defRPr>
      </a:lvl8pPr>
      <a:lvl9pPr marL="2391412" indent="-140671" algn="l" defTabSz="562685" rtl="0" eaLnBrk="1" latinLnBrk="0" hangingPunct="1">
        <a:spcBef>
          <a:spcPct val="20000"/>
        </a:spcBef>
        <a:buFont typeface="Arial" panose="020B0604020202020204" pitchFamily="34" charset="0"/>
        <a:buChar char="•"/>
        <a:defRPr sz="12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1pPr>
      <a:lvl2pPr marL="281342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2pPr>
      <a:lvl3pPr marL="562685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3pPr>
      <a:lvl4pPr marL="844028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4pPr>
      <a:lvl5pPr marL="1125370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5pPr>
      <a:lvl6pPr marL="1406713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6pPr>
      <a:lvl7pPr marL="1688055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7pPr>
      <a:lvl8pPr marL="1969398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8pPr>
      <a:lvl9pPr marL="2250741" algn="l" defTabSz="562685" rtl="0" eaLnBrk="1" latinLnBrk="0" hangingPunct="1">
        <a:defRPr sz="11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334" y="1957395"/>
            <a:ext cx="8662844" cy="3295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2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688" y="5944052"/>
            <a:ext cx="8738824" cy="32259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3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69689" y="10024819"/>
            <a:ext cx="8883029" cy="3261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4" name="ZoneTexte 203"/>
          <p:cNvSpPr txBox="1"/>
          <p:nvPr/>
        </p:nvSpPr>
        <p:spPr>
          <a:xfrm>
            <a:off x="303824" y="958384"/>
            <a:ext cx="1323342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dirty="0" err="1" smtClean="0">
                <a:latin typeface="Palatino Linotype" panose="02040502050505030304" pitchFamily="18" charset="0"/>
              </a:rPr>
              <a:t>Supplementary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smtClean="0">
                <a:latin typeface="Palatino Linotype" panose="02040502050505030304" pitchFamily="18" charset="0"/>
              </a:rPr>
              <a:t>Figure S10: </a:t>
            </a:r>
            <a:r>
              <a:rPr lang="fr-FR" sz="1600" dirty="0" smtClean="0">
                <a:latin typeface="Palatino Linotype" panose="02040502050505030304" pitchFamily="18" charset="0"/>
              </a:rPr>
              <a:t>Antiviral </a:t>
            </a:r>
            <a:r>
              <a:rPr lang="fr-FR" sz="1600" dirty="0" err="1" smtClean="0">
                <a:latin typeface="Palatino Linotype" panose="02040502050505030304" pitchFamily="18" charset="0"/>
              </a:rPr>
              <a:t>analysis</a:t>
            </a:r>
            <a:r>
              <a:rPr lang="fr-FR" sz="1600" dirty="0" smtClean="0">
                <a:latin typeface="Palatino Linotype" panose="02040502050505030304" pitchFamily="18" charset="0"/>
              </a:rPr>
              <a:t> of the </a:t>
            </a:r>
            <a:r>
              <a:rPr lang="fr-FR" sz="1600" dirty="0" err="1" smtClean="0">
                <a:latin typeface="Palatino Linotype" panose="02040502050505030304" pitchFamily="18" charset="0"/>
              </a:rPr>
              <a:t>effect</a:t>
            </a:r>
            <a:r>
              <a:rPr lang="fr-FR" sz="1600" dirty="0" smtClean="0">
                <a:latin typeface="Palatino Linotype" panose="02040502050505030304" pitchFamily="18" charset="0"/>
              </a:rPr>
              <a:t> of (A) GCV, (B) ACV and (C) APD </a:t>
            </a:r>
            <a:r>
              <a:rPr lang="fr-FR" sz="1600" dirty="0" err="1" smtClean="0">
                <a:latin typeface="Palatino Linotype" panose="02040502050505030304" pitchFamily="18" charset="0"/>
              </a:rPr>
              <a:t>using</a:t>
            </a:r>
            <a:r>
              <a:rPr lang="fr-FR" sz="1600" dirty="0" smtClean="0">
                <a:latin typeface="Palatino Linotype" panose="02040502050505030304" pitchFamily="18" charset="0"/>
              </a:rPr>
              <a:t> (i) </a:t>
            </a:r>
            <a:r>
              <a:rPr lang="fr-FR" sz="1600" dirty="0" err="1" smtClean="0">
                <a:latin typeface="Palatino Linotype" panose="02040502050505030304" pitchFamily="18" charset="0"/>
              </a:rPr>
              <a:t>impedancemetry</a:t>
            </a:r>
            <a:r>
              <a:rPr lang="fr-FR" sz="1600" dirty="0" smtClean="0">
                <a:latin typeface="Palatino Linotype" panose="02040502050505030304" pitchFamily="18" charset="0"/>
              </a:rPr>
              <a:t> </a:t>
            </a:r>
            <a:r>
              <a:rPr lang="fr-FR" sz="1600" dirty="0" err="1" smtClean="0">
                <a:latin typeface="Palatino Linotype" panose="02040502050505030304" pitchFamily="18" charset="0"/>
              </a:rPr>
              <a:t>measurement</a:t>
            </a:r>
            <a:r>
              <a:rPr lang="fr-FR" sz="1600" dirty="0" smtClean="0">
                <a:latin typeface="Palatino Linotype" panose="02040502050505030304" pitchFamily="18" charset="0"/>
              </a:rPr>
              <a:t>, (ii) viral </a:t>
            </a:r>
            <a:r>
              <a:rPr lang="fr-FR" sz="1600" dirty="0" err="1" smtClean="0">
                <a:latin typeface="Palatino Linotype" panose="02040502050505030304" pitchFamily="18" charset="0"/>
              </a:rPr>
              <a:t>load</a:t>
            </a:r>
            <a:r>
              <a:rPr lang="fr-FR" sz="1600" dirty="0" smtClean="0">
                <a:latin typeface="Palatino Linotype" panose="02040502050505030304" pitchFamily="18" charset="0"/>
              </a:rPr>
              <a:t> quantification</a:t>
            </a:r>
            <a:r>
              <a:rPr lang="en-GB" sz="1600" dirty="0" smtClean="0">
                <a:latin typeface="Palatino Linotype" panose="02040502050505030304" pitchFamily="18" charset="0"/>
              </a:rPr>
              <a:t>.</a:t>
            </a:r>
            <a:endParaRPr lang="fr-FR" sz="1600" b="1" dirty="0">
              <a:solidFill>
                <a:srgbClr val="FF0000"/>
              </a:solidFill>
              <a:latin typeface="Palatino Linotype" panose="02040502050505030304" pitchFamily="18" charset="0"/>
            </a:endParaRPr>
          </a:p>
        </p:txBody>
      </p:sp>
      <p:sp>
        <p:nvSpPr>
          <p:cNvPr id="205" name="ZoneTexte 204"/>
          <p:cNvSpPr txBox="1"/>
          <p:nvPr/>
        </p:nvSpPr>
        <p:spPr>
          <a:xfrm>
            <a:off x="213688" y="1476326"/>
            <a:ext cx="11825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latin typeface="Palatino Linotype" panose="02040502050505030304" pitchFamily="18" charset="0"/>
              </a:rPr>
              <a:t>A</a:t>
            </a:r>
            <a:endParaRPr lang="fr-FR" sz="2400" b="1" dirty="0">
              <a:latin typeface="Palatino Linotype" panose="02040502050505030304" pitchFamily="18" charset="0"/>
            </a:endParaRPr>
          </a:p>
        </p:txBody>
      </p:sp>
      <p:sp>
        <p:nvSpPr>
          <p:cNvPr id="206" name="ZoneTexte 205"/>
          <p:cNvSpPr txBox="1"/>
          <p:nvPr/>
        </p:nvSpPr>
        <p:spPr>
          <a:xfrm>
            <a:off x="162470" y="5364758"/>
            <a:ext cx="11825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latin typeface="Palatino Linotype" panose="02040502050505030304" pitchFamily="18" charset="0"/>
              </a:rPr>
              <a:t>B</a:t>
            </a:r>
            <a:endParaRPr lang="fr-FR" sz="2400" b="1" dirty="0">
              <a:latin typeface="Palatino Linotype" panose="02040502050505030304" pitchFamily="18" charset="0"/>
            </a:endParaRPr>
          </a:p>
        </p:txBody>
      </p:sp>
      <p:sp>
        <p:nvSpPr>
          <p:cNvPr id="207" name="ZoneTexte 206"/>
          <p:cNvSpPr txBox="1"/>
          <p:nvPr/>
        </p:nvSpPr>
        <p:spPr>
          <a:xfrm>
            <a:off x="195647" y="9397206"/>
            <a:ext cx="11825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latin typeface="Palatino Linotype" panose="02040502050505030304" pitchFamily="18" charset="0"/>
              </a:rPr>
              <a:t>C</a:t>
            </a:r>
            <a:endParaRPr lang="fr-FR" sz="2400" b="1" dirty="0">
              <a:latin typeface="Palatino Linotype" panose="02040502050505030304" pitchFamily="18" charset="0"/>
            </a:endParaRPr>
          </a:p>
        </p:txBody>
      </p:sp>
      <p:sp>
        <p:nvSpPr>
          <p:cNvPr id="208" name="ZoneTexte 207"/>
          <p:cNvSpPr txBox="1"/>
          <p:nvPr/>
        </p:nvSpPr>
        <p:spPr>
          <a:xfrm>
            <a:off x="864196" y="2153642"/>
            <a:ext cx="1368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) GCV</a:t>
            </a:r>
            <a:endParaRPr lang="fr-FR" dirty="0">
              <a:latin typeface="Palatino Linotype" panose="02040502050505030304" pitchFamily="18" charset="0"/>
            </a:endParaRPr>
          </a:p>
        </p:txBody>
      </p:sp>
      <p:sp>
        <p:nvSpPr>
          <p:cNvPr id="209" name="ZoneTexte 208"/>
          <p:cNvSpPr txBox="1"/>
          <p:nvPr/>
        </p:nvSpPr>
        <p:spPr>
          <a:xfrm>
            <a:off x="928194" y="6031187"/>
            <a:ext cx="13041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) ACV</a:t>
            </a:r>
            <a:endParaRPr lang="fr-FR" dirty="0">
              <a:latin typeface="Palatino Linotype" panose="02040502050505030304" pitchFamily="18" charset="0"/>
            </a:endParaRPr>
          </a:p>
        </p:txBody>
      </p:sp>
      <p:sp>
        <p:nvSpPr>
          <p:cNvPr id="210" name="ZoneTexte 209"/>
          <p:cNvSpPr txBox="1"/>
          <p:nvPr/>
        </p:nvSpPr>
        <p:spPr>
          <a:xfrm>
            <a:off x="864196" y="1006079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</a:t>
            </a:r>
            <a:r>
              <a:rPr lang="fr-FR" smtClean="0">
                <a:latin typeface="Palatino Linotype" panose="02040502050505030304" pitchFamily="18" charset="0"/>
              </a:rPr>
              <a:t>) APD</a:t>
            </a:r>
            <a:endParaRPr lang="fr-FR" dirty="0">
              <a:latin typeface="Palatino Linotype" panose="02040502050505030304" pitchFamily="18" charset="0"/>
            </a:endParaRPr>
          </a:p>
        </p:txBody>
      </p:sp>
      <p:pic>
        <p:nvPicPr>
          <p:cNvPr id="212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915"/>
          <a:stretch/>
        </p:blipFill>
        <p:spPr bwMode="auto">
          <a:xfrm>
            <a:off x="10225236" y="5912383"/>
            <a:ext cx="4114564" cy="31535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3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470" t="14596" b="70807"/>
          <a:stretch/>
        </p:blipFill>
        <p:spPr bwMode="auto">
          <a:xfrm>
            <a:off x="12745516" y="6400519"/>
            <a:ext cx="1345278" cy="4603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4" name="ZoneTexte 213"/>
          <p:cNvSpPr txBox="1"/>
          <p:nvPr/>
        </p:nvSpPr>
        <p:spPr>
          <a:xfrm>
            <a:off x="9073108" y="6665103"/>
            <a:ext cx="861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100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15" name="ZoneTexte 214"/>
          <p:cNvSpPr txBox="1"/>
          <p:nvPr/>
        </p:nvSpPr>
        <p:spPr>
          <a:xfrm>
            <a:off x="9073108" y="7572262"/>
            <a:ext cx="861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50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16" name="Connecteur droit avec flèche 215"/>
          <p:cNvCxnSpPr/>
          <p:nvPr/>
        </p:nvCxnSpPr>
        <p:spPr>
          <a:xfrm flipH="1">
            <a:off x="8859589" y="6818992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Connecteur droit avec flèche 216"/>
          <p:cNvCxnSpPr/>
          <p:nvPr/>
        </p:nvCxnSpPr>
        <p:spPr>
          <a:xfrm flipH="1">
            <a:off x="8862830" y="769567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Connecteur droit avec flèche 217"/>
          <p:cNvCxnSpPr/>
          <p:nvPr/>
        </p:nvCxnSpPr>
        <p:spPr>
          <a:xfrm flipH="1">
            <a:off x="8877255" y="8110043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ZoneTexte 218"/>
          <p:cNvSpPr txBox="1"/>
          <p:nvPr/>
        </p:nvSpPr>
        <p:spPr>
          <a:xfrm>
            <a:off x="9073108" y="7971394"/>
            <a:ext cx="8615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25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20" name="Connecteur droit avec flèche 219"/>
          <p:cNvCxnSpPr/>
          <p:nvPr/>
        </p:nvCxnSpPr>
        <p:spPr>
          <a:xfrm flipH="1">
            <a:off x="8871277" y="7408631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ZoneTexte 220"/>
          <p:cNvSpPr txBox="1"/>
          <p:nvPr/>
        </p:nvSpPr>
        <p:spPr>
          <a:xfrm>
            <a:off x="9080449" y="7244870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Palatino Linotype" panose="02040502050505030304" pitchFamily="18" charset="0"/>
              </a:rPr>
              <a:t>Cells</a:t>
            </a:r>
            <a:r>
              <a:rPr lang="fr-FR" sz="1100" b="1" dirty="0" smtClean="0">
                <a:latin typeface="Palatino Linotype" panose="02040502050505030304" pitchFamily="18" charset="0"/>
              </a:rPr>
              <a:t>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22" name="ZoneTexte 221"/>
          <p:cNvSpPr txBox="1"/>
          <p:nvPr/>
        </p:nvSpPr>
        <p:spPr>
          <a:xfrm>
            <a:off x="9103915" y="8375215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Virus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23" name="Connecteur droit avec flèche 222"/>
          <p:cNvCxnSpPr/>
          <p:nvPr/>
        </p:nvCxnSpPr>
        <p:spPr>
          <a:xfrm flipH="1">
            <a:off x="8884830" y="850602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Connecteur droit avec flèche 223"/>
          <p:cNvCxnSpPr/>
          <p:nvPr/>
        </p:nvCxnSpPr>
        <p:spPr>
          <a:xfrm flipH="1" flipV="1">
            <a:off x="8862830" y="8627713"/>
            <a:ext cx="256918" cy="118363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ZoneTexte 224"/>
          <p:cNvSpPr txBox="1"/>
          <p:nvPr/>
        </p:nvSpPr>
        <p:spPr>
          <a:xfrm>
            <a:off x="9080449" y="8662598"/>
            <a:ext cx="1072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12,5 to 7,8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26" name="ZoneTexte 225"/>
          <p:cNvSpPr txBox="1"/>
          <p:nvPr/>
        </p:nvSpPr>
        <p:spPr>
          <a:xfrm>
            <a:off x="10369252" y="5859522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i)</a:t>
            </a:r>
            <a:endParaRPr lang="fr-FR" dirty="0">
              <a:latin typeface="Palatino Linotype" panose="02040502050505030304" pitchFamily="18" charset="0"/>
            </a:endParaRPr>
          </a:p>
        </p:txBody>
      </p:sp>
      <p:pic>
        <p:nvPicPr>
          <p:cNvPr id="228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12"/>
          <a:stretch/>
        </p:blipFill>
        <p:spPr bwMode="auto">
          <a:xfrm>
            <a:off x="10196491" y="10062643"/>
            <a:ext cx="4133201" cy="3258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9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934" t="16520" r="2825" b="73077"/>
          <a:stretch/>
        </p:blipFill>
        <p:spPr bwMode="auto">
          <a:xfrm>
            <a:off x="12745516" y="10748518"/>
            <a:ext cx="1192443" cy="3389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0" name="ZoneTexte 229"/>
          <p:cNvSpPr txBox="1"/>
          <p:nvPr/>
        </p:nvSpPr>
        <p:spPr>
          <a:xfrm>
            <a:off x="10200853" y="10030497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i)</a:t>
            </a:r>
            <a:endParaRPr lang="fr-FR" dirty="0">
              <a:latin typeface="Palatino Linotype" panose="02040502050505030304" pitchFamily="18" charset="0"/>
            </a:endParaRPr>
          </a:p>
        </p:txBody>
      </p:sp>
      <p:cxnSp>
        <p:nvCxnSpPr>
          <p:cNvPr id="231" name="Connecteur droit avec flèche 230"/>
          <p:cNvCxnSpPr/>
          <p:nvPr/>
        </p:nvCxnSpPr>
        <p:spPr>
          <a:xfrm flipH="1">
            <a:off x="8713068" y="11127445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Connecteur droit avec flèche 231"/>
          <p:cNvCxnSpPr/>
          <p:nvPr/>
        </p:nvCxnSpPr>
        <p:spPr>
          <a:xfrm flipH="1">
            <a:off x="8713068" y="1145891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Connecteur droit avec flèche 232"/>
          <p:cNvCxnSpPr/>
          <p:nvPr/>
        </p:nvCxnSpPr>
        <p:spPr>
          <a:xfrm flipH="1">
            <a:off x="8713068" y="11677985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Connecteur droit avec flèche 233"/>
          <p:cNvCxnSpPr/>
          <p:nvPr/>
        </p:nvCxnSpPr>
        <p:spPr>
          <a:xfrm flipH="1">
            <a:off x="8713068" y="1218281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Connecteur droit avec flèche 234"/>
          <p:cNvCxnSpPr/>
          <p:nvPr/>
        </p:nvCxnSpPr>
        <p:spPr>
          <a:xfrm flipH="1">
            <a:off x="8713068" y="1258286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Connecteur droit avec flèche 235"/>
          <p:cNvCxnSpPr/>
          <p:nvPr/>
        </p:nvCxnSpPr>
        <p:spPr>
          <a:xfrm flipH="1" flipV="1">
            <a:off x="8713068" y="12683046"/>
            <a:ext cx="242069" cy="5715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Connecteur droit avec flèche 236"/>
          <p:cNvCxnSpPr/>
          <p:nvPr/>
        </p:nvCxnSpPr>
        <p:spPr>
          <a:xfrm flipH="1" flipV="1">
            <a:off x="8713068" y="12740196"/>
            <a:ext cx="239444" cy="158874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8" name="ZoneTexte 237"/>
          <p:cNvSpPr txBox="1"/>
          <p:nvPr/>
        </p:nvSpPr>
        <p:spPr>
          <a:xfrm>
            <a:off x="8983801" y="11010750"/>
            <a:ext cx="13134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2,5 and 1,25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39" name="ZoneTexte 238"/>
          <p:cNvSpPr txBox="1"/>
          <p:nvPr/>
        </p:nvSpPr>
        <p:spPr>
          <a:xfrm>
            <a:off x="8983801" y="11328105"/>
            <a:ext cx="13134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Palatino Linotype" panose="02040502050505030304" pitchFamily="18" charset="0"/>
              </a:rPr>
              <a:t>Cells</a:t>
            </a:r>
            <a:r>
              <a:rPr lang="fr-FR" sz="1100" b="1" dirty="0" smtClean="0">
                <a:latin typeface="Palatino Linotype" panose="02040502050505030304" pitchFamily="18" charset="0"/>
              </a:rPr>
              <a:t>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40" name="ZoneTexte 239"/>
          <p:cNvSpPr txBox="1"/>
          <p:nvPr/>
        </p:nvSpPr>
        <p:spPr>
          <a:xfrm>
            <a:off x="8983801" y="11611310"/>
            <a:ext cx="1072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63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41" name="ZoneTexte 240"/>
          <p:cNvSpPr txBox="1"/>
          <p:nvPr/>
        </p:nvSpPr>
        <p:spPr>
          <a:xfrm>
            <a:off x="8983801" y="12052005"/>
            <a:ext cx="1072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31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42" name="ZoneTexte 241"/>
          <p:cNvSpPr txBox="1"/>
          <p:nvPr/>
        </p:nvSpPr>
        <p:spPr>
          <a:xfrm>
            <a:off x="8983801" y="12421436"/>
            <a:ext cx="10727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16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43" name="ZoneTexte 242"/>
          <p:cNvSpPr txBox="1"/>
          <p:nvPr/>
        </p:nvSpPr>
        <p:spPr>
          <a:xfrm>
            <a:off x="8983801" y="12573836"/>
            <a:ext cx="12721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08 to 0,02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44" name="ZoneTexte 243"/>
          <p:cNvSpPr txBox="1"/>
          <p:nvPr/>
        </p:nvSpPr>
        <p:spPr>
          <a:xfrm>
            <a:off x="8983801" y="12819633"/>
            <a:ext cx="13134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Virus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pic>
        <p:nvPicPr>
          <p:cNvPr id="246" name="Picture 4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659"/>
          <a:stretch/>
        </p:blipFill>
        <p:spPr bwMode="auto">
          <a:xfrm>
            <a:off x="10168939" y="2051836"/>
            <a:ext cx="3800713" cy="31067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7" name="Picture 4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608" t="10259" b="68169"/>
          <a:stretch/>
        </p:blipFill>
        <p:spPr bwMode="auto">
          <a:xfrm>
            <a:off x="12745516" y="2507203"/>
            <a:ext cx="1298163" cy="670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8" name="ZoneTexte 247"/>
          <p:cNvSpPr txBox="1"/>
          <p:nvPr/>
        </p:nvSpPr>
        <p:spPr>
          <a:xfrm>
            <a:off x="10200853" y="1908374"/>
            <a:ext cx="9361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>
                <a:latin typeface="Palatino Linotype" panose="02040502050505030304" pitchFamily="18" charset="0"/>
              </a:rPr>
              <a:t>(ii)</a:t>
            </a:r>
            <a:endParaRPr lang="fr-FR" dirty="0">
              <a:latin typeface="Palatino Linotype" panose="02040502050505030304" pitchFamily="18" charset="0"/>
            </a:endParaRPr>
          </a:p>
        </p:txBody>
      </p:sp>
      <p:cxnSp>
        <p:nvCxnSpPr>
          <p:cNvPr id="249" name="Connecteur droit avec flèche 248"/>
          <p:cNvCxnSpPr/>
          <p:nvPr/>
        </p:nvCxnSpPr>
        <p:spPr>
          <a:xfrm flipH="1">
            <a:off x="8872324" y="4716686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ZoneTexte 249"/>
          <p:cNvSpPr txBox="1"/>
          <p:nvPr/>
        </p:nvSpPr>
        <p:spPr>
          <a:xfrm>
            <a:off x="9120021" y="458588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Virus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51" name="Connecteur droit avec flèche 250"/>
          <p:cNvCxnSpPr/>
          <p:nvPr/>
        </p:nvCxnSpPr>
        <p:spPr>
          <a:xfrm flipH="1">
            <a:off x="8874201" y="2916486"/>
            <a:ext cx="215410" cy="66131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ZoneTexte 251"/>
          <p:cNvSpPr txBox="1"/>
          <p:nvPr/>
        </p:nvSpPr>
        <p:spPr>
          <a:xfrm>
            <a:off x="9120021" y="278568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err="1" smtClean="0">
                <a:latin typeface="Palatino Linotype" panose="02040502050505030304" pitchFamily="18" charset="0"/>
              </a:rPr>
              <a:t>Cells</a:t>
            </a:r>
            <a:r>
              <a:rPr lang="fr-FR" sz="1100" b="1" dirty="0" smtClean="0">
                <a:latin typeface="Palatino Linotype" panose="02040502050505030304" pitchFamily="18" charset="0"/>
              </a:rPr>
              <a:t> + DMSO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53" name="Connecteur droit avec flèche 252"/>
          <p:cNvCxnSpPr/>
          <p:nvPr/>
        </p:nvCxnSpPr>
        <p:spPr>
          <a:xfrm flipH="1" flipV="1">
            <a:off x="8857084" y="3304466"/>
            <a:ext cx="232527" cy="762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Connecteur droit avec flèche 253"/>
          <p:cNvCxnSpPr/>
          <p:nvPr/>
        </p:nvCxnSpPr>
        <p:spPr>
          <a:xfrm flipH="1">
            <a:off x="8872324" y="385259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Connecteur droit avec flèche 254"/>
          <p:cNvCxnSpPr/>
          <p:nvPr/>
        </p:nvCxnSpPr>
        <p:spPr>
          <a:xfrm flipH="1">
            <a:off x="8872324" y="3982302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Connecteur droit avec flèche 255"/>
          <p:cNvCxnSpPr/>
          <p:nvPr/>
        </p:nvCxnSpPr>
        <p:spPr>
          <a:xfrm flipH="1">
            <a:off x="8872324" y="4212630"/>
            <a:ext cx="256918" cy="0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Connecteur droit avec flèche 256"/>
          <p:cNvCxnSpPr/>
          <p:nvPr/>
        </p:nvCxnSpPr>
        <p:spPr>
          <a:xfrm flipH="1">
            <a:off x="8888198" y="4535525"/>
            <a:ext cx="241044" cy="109153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ZoneTexte 257"/>
          <p:cNvSpPr txBox="1"/>
          <p:nvPr/>
        </p:nvSpPr>
        <p:spPr>
          <a:xfrm>
            <a:off x="9120021" y="318128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50  and 25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59" name="ZoneTexte 258"/>
          <p:cNvSpPr txBox="1"/>
          <p:nvPr/>
        </p:nvSpPr>
        <p:spPr>
          <a:xfrm>
            <a:off x="9120021" y="255782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12,5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60" name="Connecteur droit avec flèche 259"/>
          <p:cNvCxnSpPr/>
          <p:nvPr/>
        </p:nvCxnSpPr>
        <p:spPr>
          <a:xfrm flipH="1">
            <a:off x="8872324" y="3690037"/>
            <a:ext cx="248761" cy="90545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1" name="ZoneTexte 260"/>
          <p:cNvSpPr txBox="1"/>
          <p:nvPr/>
        </p:nvSpPr>
        <p:spPr>
          <a:xfrm>
            <a:off x="9120021" y="300492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6,25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62" name="ZoneTexte 261"/>
          <p:cNvSpPr txBox="1"/>
          <p:nvPr/>
        </p:nvSpPr>
        <p:spPr>
          <a:xfrm>
            <a:off x="9120021" y="3859905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3,13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63" name="ZoneTexte 262"/>
          <p:cNvSpPr txBox="1"/>
          <p:nvPr/>
        </p:nvSpPr>
        <p:spPr>
          <a:xfrm>
            <a:off x="9120021" y="3518972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1,56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64" name="Connecteur droit avec flèche 263"/>
          <p:cNvCxnSpPr/>
          <p:nvPr/>
        </p:nvCxnSpPr>
        <p:spPr>
          <a:xfrm flipH="1">
            <a:off x="8893084" y="2694625"/>
            <a:ext cx="208124" cy="182111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5" name="ZoneTexte 264"/>
          <p:cNvSpPr txBox="1"/>
          <p:nvPr/>
        </p:nvSpPr>
        <p:spPr>
          <a:xfrm>
            <a:off x="9120021" y="3690037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78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cxnSp>
        <p:nvCxnSpPr>
          <p:cNvPr id="266" name="Connecteur droit avec flèche 265"/>
          <p:cNvCxnSpPr/>
          <p:nvPr/>
        </p:nvCxnSpPr>
        <p:spPr>
          <a:xfrm flipH="1" flipV="1">
            <a:off x="8883347" y="3084691"/>
            <a:ext cx="221504" cy="51035"/>
          </a:xfrm>
          <a:prstGeom prst="straightConnector1">
            <a:avLst/>
          </a:prstGeom>
          <a:ln w="1270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ZoneTexte 266"/>
          <p:cNvSpPr txBox="1"/>
          <p:nvPr/>
        </p:nvSpPr>
        <p:spPr>
          <a:xfrm>
            <a:off x="9120021" y="4121515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39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268" name="ZoneTexte 267"/>
          <p:cNvSpPr txBox="1"/>
          <p:nvPr/>
        </p:nvSpPr>
        <p:spPr>
          <a:xfrm>
            <a:off x="9120021" y="4369351"/>
            <a:ext cx="1535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Palatino Linotype" panose="02040502050505030304" pitchFamily="18" charset="0"/>
              </a:rPr>
              <a:t>0,20 and 0,10 µM</a:t>
            </a:r>
            <a:endParaRPr lang="fr-FR" sz="1100" b="1" dirty="0">
              <a:latin typeface="Palatino Linotype" panose="0204050205050503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1456708" y="5000987"/>
            <a:ext cx="15921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Infection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cxnSp>
        <p:nvCxnSpPr>
          <p:cNvPr id="9" name="Connecteur droit 8"/>
          <p:cNvCxnSpPr/>
          <p:nvPr/>
        </p:nvCxnSpPr>
        <p:spPr>
          <a:xfrm flipV="1">
            <a:off x="3847004" y="2015530"/>
            <a:ext cx="0" cy="2759291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9" name="ZoneTexte 268"/>
          <p:cNvSpPr txBox="1"/>
          <p:nvPr/>
        </p:nvSpPr>
        <p:spPr>
          <a:xfrm>
            <a:off x="3504176" y="5000987"/>
            <a:ext cx="15921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48 </a:t>
            </a:r>
            <a:r>
              <a:rPr lang="fr-FR" sz="1200" i="1" dirty="0" err="1" smtClean="0">
                <a:latin typeface="Palatino Linotype" panose="02040502050505030304" pitchFamily="18" charset="0"/>
              </a:rPr>
              <a:t>hpi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cxnSp>
        <p:nvCxnSpPr>
          <p:cNvPr id="13" name="Connecteur droit avec flèche 12"/>
          <p:cNvCxnSpPr/>
          <p:nvPr/>
        </p:nvCxnSpPr>
        <p:spPr>
          <a:xfrm>
            <a:off x="1809825" y="4751834"/>
            <a:ext cx="0" cy="207004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0" name="Connecteur droit avec flèche 269"/>
          <p:cNvCxnSpPr/>
          <p:nvPr/>
        </p:nvCxnSpPr>
        <p:spPr>
          <a:xfrm>
            <a:off x="3847004" y="4761326"/>
            <a:ext cx="0" cy="207004"/>
          </a:xfrm>
          <a:prstGeom prst="straightConnector1">
            <a:avLst/>
          </a:prstGeom>
          <a:ln>
            <a:solidFill>
              <a:srgbClr val="FF0000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1" name="Connecteur droit avec flèche 270"/>
          <p:cNvCxnSpPr/>
          <p:nvPr/>
        </p:nvCxnSpPr>
        <p:spPr>
          <a:xfrm>
            <a:off x="2153990" y="8686408"/>
            <a:ext cx="0" cy="207004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ZoneTexte 271"/>
          <p:cNvSpPr txBox="1"/>
          <p:nvPr/>
        </p:nvSpPr>
        <p:spPr>
          <a:xfrm>
            <a:off x="1809825" y="8897727"/>
            <a:ext cx="15921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Infection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cxnSp>
        <p:nvCxnSpPr>
          <p:cNvPr id="273" name="Connecteur droit avec flèche 272"/>
          <p:cNvCxnSpPr/>
          <p:nvPr/>
        </p:nvCxnSpPr>
        <p:spPr>
          <a:xfrm>
            <a:off x="4863300" y="8714655"/>
            <a:ext cx="0" cy="207004"/>
          </a:xfrm>
          <a:prstGeom prst="straightConnector1">
            <a:avLst/>
          </a:prstGeom>
          <a:ln>
            <a:solidFill>
              <a:srgbClr val="FF0000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4" name="Connecteur droit 273"/>
          <p:cNvCxnSpPr/>
          <p:nvPr/>
        </p:nvCxnSpPr>
        <p:spPr>
          <a:xfrm flipV="1">
            <a:off x="4862736" y="5975970"/>
            <a:ext cx="0" cy="2759291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ZoneTexte 274"/>
          <p:cNvSpPr txBox="1"/>
          <p:nvPr/>
        </p:nvSpPr>
        <p:spPr>
          <a:xfrm>
            <a:off x="3994193" y="8897727"/>
            <a:ext cx="122413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              48 </a:t>
            </a:r>
            <a:r>
              <a:rPr lang="fr-FR" sz="1200" i="1" dirty="0" err="1" smtClean="0">
                <a:latin typeface="Palatino Linotype" panose="02040502050505030304" pitchFamily="18" charset="0"/>
              </a:rPr>
              <a:t>hpi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pic>
        <p:nvPicPr>
          <p:cNvPr id="276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56" t="93277" r="42463"/>
          <a:stretch/>
        </p:blipFill>
        <p:spPr bwMode="auto">
          <a:xfrm>
            <a:off x="3514388" y="8925445"/>
            <a:ext cx="936104" cy="22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77" name="Connecteur droit 276"/>
          <p:cNvCxnSpPr/>
          <p:nvPr/>
        </p:nvCxnSpPr>
        <p:spPr>
          <a:xfrm flipV="1">
            <a:off x="4540015" y="10060794"/>
            <a:ext cx="0" cy="2759291"/>
          </a:xfrm>
          <a:prstGeom prst="line">
            <a:avLst/>
          </a:prstGeom>
          <a:ln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8" name="Connecteur droit avec flèche 277"/>
          <p:cNvCxnSpPr/>
          <p:nvPr/>
        </p:nvCxnSpPr>
        <p:spPr>
          <a:xfrm>
            <a:off x="4539779" y="12809875"/>
            <a:ext cx="0" cy="207004"/>
          </a:xfrm>
          <a:prstGeom prst="straightConnector1">
            <a:avLst/>
          </a:prstGeom>
          <a:ln>
            <a:solidFill>
              <a:srgbClr val="FF0000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0" name="ZoneTexte 279"/>
          <p:cNvSpPr txBox="1"/>
          <p:nvPr/>
        </p:nvSpPr>
        <p:spPr>
          <a:xfrm>
            <a:off x="3734357" y="13023619"/>
            <a:ext cx="122413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              48 </a:t>
            </a:r>
            <a:r>
              <a:rPr lang="fr-FR" sz="1200" i="1" dirty="0" err="1" smtClean="0">
                <a:latin typeface="Palatino Linotype" panose="02040502050505030304" pitchFamily="18" charset="0"/>
              </a:rPr>
              <a:t>hpi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pic>
        <p:nvPicPr>
          <p:cNvPr id="279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56" t="93277" r="42463"/>
          <a:stretch/>
        </p:blipFill>
        <p:spPr bwMode="auto">
          <a:xfrm>
            <a:off x="2912821" y="13051337"/>
            <a:ext cx="936104" cy="22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81" name="Connecteur droit avec flèche 280"/>
          <p:cNvCxnSpPr/>
          <p:nvPr/>
        </p:nvCxnSpPr>
        <p:spPr>
          <a:xfrm>
            <a:off x="1913906" y="12795568"/>
            <a:ext cx="0" cy="207004"/>
          </a:xfrm>
          <a:prstGeom prst="straightConnector1">
            <a:avLst/>
          </a:prstGeom>
          <a:ln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ZoneTexte 281"/>
          <p:cNvSpPr txBox="1"/>
          <p:nvPr/>
        </p:nvSpPr>
        <p:spPr>
          <a:xfrm>
            <a:off x="1595385" y="13023619"/>
            <a:ext cx="15921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i="1" dirty="0" smtClean="0">
                <a:latin typeface="Palatino Linotype" panose="02040502050505030304" pitchFamily="18" charset="0"/>
              </a:rPr>
              <a:t>Infection</a:t>
            </a:r>
            <a:endParaRPr lang="en-GB" sz="1200" i="1" dirty="0">
              <a:latin typeface="Palatino Linotype" panose="02040502050505030304" pitchFamily="18" charset="0"/>
            </a:endParaRPr>
          </a:p>
        </p:txBody>
      </p:sp>
      <p:sp>
        <p:nvSpPr>
          <p:cNvPr id="84" name="ZoneTexte 83"/>
          <p:cNvSpPr txBox="1"/>
          <p:nvPr/>
        </p:nvSpPr>
        <p:spPr>
          <a:xfrm>
            <a:off x="303824" y="90364"/>
            <a:ext cx="1366582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Palatino Linotype" panose="02040502050505030304" pitchFamily="18" charset="0"/>
              </a:rPr>
              <a:t>Identification of a new equid herpesvirus 1 DNA polymerase (ORF30) genotype with the isolation of a C2254/H752 strain in French horses. </a:t>
            </a:r>
            <a:endParaRPr lang="en-GB" dirty="0" smtClean="0">
              <a:latin typeface="Palatino Linotype" panose="02040502050505030304" pitchFamily="18" charset="0"/>
            </a:endParaRPr>
          </a:p>
          <a:p>
            <a:r>
              <a:rPr lang="en-GB" dirty="0" smtClean="0">
                <a:latin typeface="Palatino Linotype" panose="02040502050505030304" pitchFamily="18" charset="0"/>
              </a:rPr>
              <a:t>Sutton </a:t>
            </a:r>
            <a:r>
              <a:rPr lang="en-GB" i="1" dirty="0" smtClean="0">
                <a:latin typeface="Palatino Linotype" panose="02040502050505030304" pitchFamily="18" charset="0"/>
              </a:rPr>
              <a:t>et al. </a:t>
            </a:r>
            <a:endParaRPr lang="fr-FR" i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92943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163</Words>
  <Application>Microsoft Office PowerPoint</Application>
  <PresentationFormat>Personnalisé</PresentationFormat>
  <Paragraphs>4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brielle</dc:creator>
  <cp:lastModifiedBy>Gabrielle</cp:lastModifiedBy>
  <cp:revision>19</cp:revision>
  <dcterms:created xsi:type="dcterms:W3CDTF">2020-07-10T15:10:08Z</dcterms:created>
  <dcterms:modified xsi:type="dcterms:W3CDTF">2020-10-11T19:21:55Z</dcterms:modified>
</cp:coreProperties>
</file>